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92FAA7-10BA-4E73-A9A5-94B9EE9888E1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3B6A7C2-F0A0-4ACE-AC95-451BF1764F76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5D0C2-4936-4F4E-B643-C8584B759B1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71A8C-DDAB-4865-B0CD-6A911BFE7D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539A66-5E0F-4289-9A4C-865822B152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C22E44-B824-415E-A065-EE98017993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1F7845-DBA0-4493-9E11-4A5273D5C1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A0FE4-5564-4AE8-B7D0-77367FBB7E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F1DD9D-4457-47FE-9796-F2FAA66A4D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AD7C28-AFFC-4E69-80C9-7F1B5B13BC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53F4F-666A-44E4-9DDB-BCDA109F42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AD894-C7A5-4E2A-A888-BF5DC18497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90EE5-3B46-4DF7-A6FE-E923A3D57F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64A9A-A39F-4092-9308-7724BA6135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F40BEB-9FD0-489E-94A0-49C2B16A0D7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6" descr=""/>
          <p:cNvPicPr/>
          <p:nvPr/>
        </p:nvPicPr>
        <p:blipFill>
          <a:blip r:embed="rId1"/>
          <a:stretch/>
        </p:blipFill>
        <p:spPr>
          <a:xfrm>
            <a:off x="1514520" y="770040"/>
            <a:ext cx="3057480" cy="16682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7" descr=""/>
          <p:cNvPicPr/>
          <p:nvPr/>
        </p:nvPicPr>
        <p:blipFill>
          <a:blip r:embed="rId2"/>
          <a:stretch/>
        </p:blipFill>
        <p:spPr>
          <a:xfrm>
            <a:off x="4867200" y="770040"/>
            <a:ext cx="3057480" cy="16682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8" descr=""/>
          <p:cNvPicPr/>
          <p:nvPr/>
        </p:nvPicPr>
        <p:blipFill>
          <a:blip r:embed="rId3"/>
          <a:stretch/>
        </p:blipFill>
        <p:spPr>
          <a:xfrm>
            <a:off x="3191040" y="2598840"/>
            <a:ext cx="3057480" cy="16682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1" name=""/>
          <p:cNvGraphicFramePr/>
          <p:nvPr/>
        </p:nvGraphicFramePr>
        <p:xfrm>
          <a:off x="279360" y="4599000"/>
          <a:ext cx="8585280" cy="977760"/>
        </p:xfrm>
        <a:graphic>
          <a:graphicData uri="http://schemas.openxmlformats.org/drawingml/2006/table">
            <a:tbl>
              <a:tblPr/>
              <a:tblGrid>
                <a:gridCol w="752400"/>
                <a:gridCol w="3114720"/>
                <a:gridCol w="1111320"/>
                <a:gridCol w="1057320"/>
                <a:gridCol w="1369800"/>
                <a:gridCol w="621000"/>
                <a:gridCol w="558720"/>
              </a:tblGrid>
              <a:tr h="319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ot numbe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cession no. (NCBI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equence identifi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ecursor m/z and charge observ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ons scor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xpe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9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longation factor 2 [Plasmodium falciparum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i|89182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TVTEESTITCLG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66.7656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50E-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19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7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ucose-6-phosphate isomerase [Plasmodium falciparum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i|1207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ANVDPNDVN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72.671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.40E-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932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2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asome beta-subunit [Plasmodium falciparum]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i|12451268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ATSSNFIQIV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321.709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.30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2" name="Text Box 119"/>
          <p:cNvSpPr/>
          <p:nvPr/>
        </p:nvSpPr>
        <p:spPr>
          <a:xfrm>
            <a:off x="2764440" y="6248520"/>
            <a:ext cx="407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le 2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Single-Peptide-Based Protein Identifica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ZoneTexte 49"/>
          <p:cNvSpPr/>
          <p:nvPr/>
        </p:nvSpPr>
        <p:spPr>
          <a:xfrm>
            <a:off x="4029480" y="762120"/>
            <a:ext cx="5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ZoneTexte 50"/>
          <p:cNvSpPr/>
          <p:nvPr/>
        </p:nvSpPr>
        <p:spPr>
          <a:xfrm>
            <a:off x="7382160" y="762120"/>
            <a:ext cx="5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7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ZoneTexte 52"/>
          <p:cNvSpPr/>
          <p:nvPr/>
        </p:nvSpPr>
        <p:spPr>
          <a:xfrm>
            <a:off x="5706000" y="2590920"/>
            <a:ext cx="54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21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9T12:30:08Z</dcterms:created>
  <dc:creator>Unknown</dc:creator>
  <dc:description/>
  <dc:language>en-US</dc:language>
  <cp:lastModifiedBy>Marylin</cp:lastModifiedBy>
  <dcterms:modified xsi:type="dcterms:W3CDTF">2010-12-10T10:56:14Z</dcterms:modified>
  <cp:revision>18</cp:revision>
  <dc:subject/>
  <dc:title>Diapositive 1</dc:title>
</cp:coreProperties>
</file>